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1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144"/>
      </p:cViewPr>
      <p:guideLst>
        <p:guide orient="horz" pos="111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8FBCA0-2A0F-1838-E69B-C3923146A2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BFBD38A-C8BA-CFFE-6FCD-627618A19F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73332AE-8107-1C2C-F616-1B727950D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7B0837-D861-8CBB-6EB5-3285FC303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05FCAA-6555-53DC-FAF9-2F3C9F2ED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6058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6E4612-6129-BBEF-FA4E-C2EF3CD41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85B40F2-4964-121D-AD35-022A73812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C487E87-BE4B-AD30-05A2-FB9539D01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6C015A-AF84-EFB3-6705-E410A384F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020D141-3C85-2752-6086-2DB303324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6919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A63911E-1B78-8314-F9C5-867B6E0F09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19459C8-020F-63A0-2989-6D967C5839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66A7532-29B9-27DD-BD6F-6BE09CF5C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1457920-7047-CA6F-4CB3-F69171B47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569CAB-CAE5-F03D-8B3A-18048A3E0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318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8027C1-BAC9-9353-E0DB-39B4AB8C8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5AECC37-DCED-59F3-5E4A-3C9B86B9D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4F77ED1-1483-AB95-D3D6-9A007B460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9A39FDD-3414-E196-60C8-945E129F8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BF88ED7-2B2B-CA97-F89D-8FA860B6B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7928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912EBF-430A-AE19-CD35-3343C4FAEC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4A9DACE-F7FE-F69E-3D3F-FFEF67B89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063AB24-9C93-2E93-B047-5DC17ADCE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6E2A2E-31C7-78C6-BC65-531CCBD56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0A4BDC-799C-11C2-3E60-4F1E06824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069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6ADD4B-AB78-2645-9471-29ED5F6FC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E81E371-8034-C1E3-FA5D-3E5D39B7EE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1EE3A20-2740-AD62-2833-5E34FE07C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4CBADF-C678-A21E-8AD1-4E3C394E7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1E2A67-428D-E328-8EA1-424446081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CEA248-84A9-D3D2-C30E-94ABECE86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7009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C1F4A8-5D9E-4731-CF25-022017030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2915157-F4ED-B5D4-4BD3-36AB19FA19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A91AE83-5D8A-E3BB-64DC-B148420ABF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28E0C1D-8ADA-4952-BD49-6D8850C3D5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1C8F182-1903-BBB7-1E2E-7AB61F1E66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0251A98-2A84-B817-DF9D-00C1A1071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ECD98C9-D884-6453-BBF1-B05E126CC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074F99A-C959-A914-6AFF-6458562CC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6970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671BDD-1466-B776-239E-713028011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55D35A7-FF8C-667F-242F-6EC28F8D1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18470B3-4D5E-004C-0712-D5EF755DB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E8B8397-0084-82EF-C6AB-FF60B99DE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384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94585EB-2616-4078-4934-680CF8FF8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9F79B12-93BC-203F-EE4C-F08A3BC8C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96D4EBF-EB3E-16F5-93BA-C54956383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5317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B51BC2-28AD-DCE2-6EC9-487EDABDD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CDBE68B-6641-2C58-B943-B5D3615479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7875866-1CEF-8EAF-0BB6-8170E5EA8B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B46C216-CDFC-712E-90B0-D4F829ED8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0E869B0-84EC-2042-4457-AA2BFA4C4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21114B-C716-10CE-1D76-7A57BD62F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898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15100E-CE90-2A11-46BF-79E36D5C7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4C1BEDEE-5355-463C-41B8-C2B90645C7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B6E1BE7-57EF-9E14-E5AD-696732F38D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E857169-C5EC-A27A-3D7D-7F6165653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80D988C-E2A3-78FD-90E7-B397CFC47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6AF265B-053F-5189-8CA3-E619F1F7C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1659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B392F08-C556-81A2-02F3-DDE45E303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B3C1E28-D751-EC9C-9ACB-829B56177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0C305B6-F764-6888-449A-62DFCC21A2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75334-E716-40C5-BE6C-DDF7195097AD}" type="datetimeFigureOut">
              <a:rPr lang="ko-KR" altLang="en-US" smtClean="0"/>
              <a:t>2023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31CF2D-F431-0E8D-D5C5-790330B4A3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69ACD59-BD75-53E1-DBEF-027B323F8F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ECDF1-1EC2-4F17-88A8-20014F30B1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1503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E1D4409-1729-39BF-3511-D0D546EF8EC8}"/>
              </a:ext>
            </a:extLst>
          </p:cNvPr>
          <p:cNvSpPr txBox="1"/>
          <p:nvPr/>
        </p:nvSpPr>
        <p:spPr>
          <a:xfrm>
            <a:off x="57150" y="47625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96C7FF6E-C984-463E-A7C4-3CBDF73B5A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6078724"/>
              </p:ext>
            </p:extLst>
          </p:nvPr>
        </p:nvGraphicFramePr>
        <p:xfrm>
          <a:off x="2107556" y="1461405"/>
          <a:ext cx="4419099" cy="134312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561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53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95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094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6227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957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0886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0403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0403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606528"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236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ypoxia</a:t>
                      </a:r>
                      <a:endParaRPr lang="ko-KR" altLang="en-US" sz="12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iRac1</a:t>
                      </a:r>
                      <a:endParaRPr lang="ko-KR" altLang="en-US" sz="12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pic>
        <p:nvPicPr>
          <p:cNvPr id="4" name="그림 3">
            <a:extLst>
              <a:ext uri="{FF2B5EF4-FFF2-40B4-BE49-F238E27FC236}">
                <a16:creationId xmlns:a16="http://schemas.microsoft.com/office/drawing/2014/main" id="{7E1A3AD0-D890-74CF-6493-00FA1FB89B0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5" r="50167" b="-1885"/>
          <a:stretch/>
        </p:blipFill>
        <p:spPr>
          <a:xfrm>
            <a:off x="3725041" y="3404859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6243FAA1-5D7B-8981-6E55-E9F2EBB595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2627169"/>
              </p:ext>
            </p:extLst>
          </p:nvPr>
        </p:nvGraphicFramePr>
        <p:xfrm>
          <a:off x="3725041" y="2819628"/>
          <a:ext cx="144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" imgW="822600" imgH="178200" progId="Photoshop.Image.13">
                  <p:embed/>
                </p:oleObj>
              </mc:Choice>
              <mc:Fallback>
                <p:oleObj name="Image" r:id="rId3" imgW="822600" imgH="17820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6243FAA1-5D7B-8981-6E55-E9F2EBB595B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25041" y="2819628"/>
                        <a:ext cx="1440000" cy="36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92EF2C6-7660-7A1E-BF26-FD2154696805}"/>
              </a:ext>
            </a:extLst>
          </p:cNvPr>
          <p:cNvSpPr txBox="1"/>
          <p:nvPr/>
        </p:nvSpPr>
        <p:spPr>
          <a:xfrm>
            <a:off x="3207070" y="2870454"/>
            <a:ext cx="489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itchFamily="34" charset="0"/>
              </a:rPr>
              <a:t>Rac1</a:t>
            </a:r>
            <a:endParaRPr lang="ko-KR" altLang="en-US" sz="1200" b="1" dirty="0">
              <a:latin typeface="Calibri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4E809D2-3843-6D27-58EE-6F64F9B7A581}"/>
              </a:ext>
            </a:extLst>
          </p:cNvPr>
          <p:cNvSpPr txBox="1"/>
          <p:nvPr/>
        </p:nvSpPr>
        <p:spPr>
          <a:xfrm>
            <a:off x="3054272" y="3455685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itchFamily="34" charset="0"/>
              </a:rPr>
              <a:t>GAPDH</a:t>
            </a:r>
            <a:endParaRPr lang="ko-KR" altLang="en-US" sz="1200" b="1" dirty="0">
              <a:latin typeface="Calibri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8A288C-8C12-3BE6-816D-E415A6DF7AC9}"/>
              </a:ext>
            </a:extLst>
          </p:cNvPr>
          <p:cNvSpPr txBox="1"/>
          <p:nvPr/>
        </p:nvSpPr>
        <p:spPr>
          <a:xfrm>
            <a:off x="5127782" y="3114368"/>
            <a:ext cx="4988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Fold</a:t>
            </a:r>
          </a:p>
          <a:p>
            <a:pPr algn="ctr"/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Change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783C18-915B-B659-B006-C7B485503742}"/>
              </a:ext>
            </a:extLst>
          </p:cNvPr>
          <p:cNvSpPr txBox="1"/>
          <p:nvPr/>
        </p:nvSpPr>
        <p:spPr>
          <a:xfrm>
            <a:off x="3806283" y="317732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1.0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BD234A-7967-CCC0-69AF-772D2BF9FD17}"/>
              </a:ext>
            </a:extLst>
          </p:cNvPr>
          <p:cNvSpPr txBox="1"/>
          <p:nvPr/>
        </p:nvSpPr>
        <p:spPr>
          <a:xfrm>
            <a:off x="4142433" y="3174279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0.5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4C8804-B0BE-BE0E-5838-F3FF2A774990}"/>
              </a:ext>
            </a:extLst>
          </p:cNvPr>
          <p:cNvSpPr txBox="1"/>
          <p:nvPr/>
        </p:nvSpPr>
        <p:spPr>
          <a:xfrm>
            <a:off x="4463779" y="3174279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1.4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797191-9882-22AC-7C4E-53D2C8718F7D}"/>
              </a:ext>
            </a:extLst>
          </p:cNvPr>
          <p:cNvSpPr txBox="1"/>
          <p:nvPr/>
        </p:nvSpPr>
        <p:spPr>
          <a:xfrm>
            <a:off x="4825620" y="3180375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1.2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7014FB-5565-BD7C-CC28-586F386D6F81}"/>
              </a:ext>
            </a:extLst>
          </p:cNvPr>
          <p:cNvSpPr txBox="1"/>
          <p:nvPr/>
        </p:nvSpPr>
        <p:spPr>
          <a:xfrm>
            <a:off x="2202031" y="161297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SNU449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9E6EA33-5817-0AE9-58C2-2BD1672D53CE}"/>
              </a:ext>
            </a:extLst>
          </p:cNvPr>
          <p:cNvSpPr txBox="1"/>
          <p:nvPr/>
        </p:nvSpPr>
        <p:spPr>
          <a:xfrm>
            <a:off x="1812282" y="158684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ko-KR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651D13-30F3-F548-E997-16B745AF673D}"/>
              </a:ext>
            </a:extLst>
          </p:cNvPr>
          <p:cNvSpPr txBox="1"/>
          <p:nvPr/>
        </p:nvSpPr>
        <p:spPr>
          <a:xfrm>
            <a:off x="6734853" y="1608609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Huh7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14D689D-5BF5-0761-BBAD-C7E3EE0BC092}"/>
              </a:ext>
            </a:extLst>
          </p:cNvPr>
          <p:cNvSpPr txBox="1"/>
          <p:nvPr/>
        </p:nvSpPr>
        <p:spPr>
          <a:xfrm>
            <a:off x="6362522" y="158166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ko-KR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BB4F43-BB01-28A8-A292-5ED4DD919577}"/>
              </a:ext>
            </a:extLst>
          </p:cNvPr>
          <p:cNvSpPr txBox="1"/>
          <p:nvPr/>
        </p:nvSpPr>
        <p:spPr>
          <a:xfrm>
            <a:off x="977191" y="4653574"/>
            <a:ext cx="1023945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 Figure S1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ac1 siRNA decreases the expression of Rac1 in SNU449 and Huh7 cells. </a:t>
            </a:r>
            <a:r>
              <a:rPr lang="en-US" altLang="ko-KR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NU449 (A) and Huh7 (B) cells were transfected with Rac1 siRNA or NC siRNA and incubated in </a:t>
            </a:r>
            <a:r>
              <a:rPr lang="en-US" altLang="ko-KR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normoxic</a:t>
            </a:r>
            <a:r>
              <a:rPr lang="en-US" altLang="ko-KR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or hypoxic conditions for </a:t>
            </a:r>
            <a:r>
              <a:rPr lang="en-US" altLang="ko-KR" sz="1100" dirty="0">
                <a:solidFill>
                  <a:srgbClr val="000000"/>
                </a:solidFill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24</a:t>
            </a:r>
            <a:r>
              <a:rPr lang="en-US" altLang="ko-KR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h. Rac1 knockdown was confirmed by Western blot analysis. </a:t>
            </a:r>
            <a:r>
              <a:rPr lang="en-US" altLang="ko-KR" sz="11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ld change was displayed as the ratio of the target protein band to the GAPDH protein band</a:t>
            </a:r>
            <a:r>
              <a:rPr lang="en-US" altLang="ko-KR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; GAPDH, glyceraldehyde-3-phosphate dehydrogenase.1</a:t>
            </a:r>
            <a:endParaRPr lang="ko-KR" altLang="en-U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개체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361257"/>
              </p:ext>
            </p:extLst>
          </p:nvPr>
        </p:nvGraphicFramePr>
        <p:xfrm>
          <a:off x="7919070" y="2820636"/>
          <a:ext cx="144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5" imgW="1292040" imgH="273960" progId="Photoshop.Image.7">
                  <p:embed/>
                </p:oleObj>
              </mc:Choice>
              <mc:Fallback>
                <p:oleObj name="Image" r:id="rId5" imgW="1292040" imgH="273960" progId="Photoshop.Image.7">
                  <p:embed/>
                  <p:pic>
                    <p:nvPicPr>
                      <p:cNvPr id="14" name="개체 13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919070" y="2820636"/>
                        <a:ext cx="1440000" cy="36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개체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3094576"/>
              </p:ext>
            </p:extLst>
          </p:nvPr>
        </p:nvGraphicFramePr>
        <p:xfrm>
          <a:off x="7923742" y="3404803"/>
          <a:ext cx="1440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7" imgW="1267560" imgH="273960" progId="Photoshop.Image.7">
                  <p:embed/>
                </p:oleObj>
              </mc:Choice>
              <mc:Fallback>
                <p:oleObj name="Image" r:id="rId7" imgW="1267560" imgH="273960" progId="Photoshop.Image.7">
                  <p:embed/>
                  <p:pic>
                    <p:nvPicPr>
                      <p:cNvPr id="18" name="개체 17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923742" y="3404803"/>
                        <a:ext cx="1440000" cy="36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96C7FF6E-C984-463E-A7C4-3CBDF73B5A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069261"/>
              </p:ext>
            </p:extLst>
          </p:nvPr>
        </p:nvGraphicFramePr>
        <p:xfrm>
          <a:off x="6264324" y="1461405"/>
          <a:ext cx="4419099" cy="134312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561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2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33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427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115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032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0886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0403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0403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606528"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236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ypoxia</a:t>
                      </a:r>
                      <a:endParaRPr lang="ko-KR" altLang="en-US" sz="12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iRac1</a:t>
                      </a:r>
                      <a:endParaRPr lang="ko-KR" altLang="en-US" sz="12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+</a:t>
                      </a:r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ko-KR" altLang="en-US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992EF2C6-7660-7A1E-BF26-FD2154696805}"/>
              </a:ext>
            </a:extLst>
          </p:cNvPr>
          <p:cNvSpPr txBox="1"/>
          <p:nvPr/>
        </p:nvSpPr>
        <p:spPr>
          <a:xfrm>
            <a:off x="7424855" y="2874570"/>
            <a:ext cx="489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itchFamily="34" charset="0"/>
              </a:rPr>
              <a:t>Rac1</a:t>
            </a:r>
            <a:endParaRPr lang="ko-KR" altLang="en-US" sz="1200" b="1" dirty="0">
              <a:latin typeface="Calibri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E809D2-3843-6D27-58EE-6F64F9B7A581}"/>
              </a:ext>
            </a:extLst>
          </p:cNvPr>
          <p:cNvSpPr txBox="1"/>
          <p:nvPr/>
        </p:nvSpPr>
        <p:spPr>
          <a:xfrm>
            <a:off x="7272057" y="345980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itchFamily="34" charset="0"/>
              </a:rPr>
              <a:t>GAPDH</a:t>
            </a:r>
            <a:endParaRPr lang="ko-KR" altLang="en-US" sz="1200" b="1" dirty="0">
              <a:latin typeface="Calibri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F8A288C-8C12-3BE6-816D-E415A6DF7AC9}"/>
              </a:ext>
            </a:extLst>
          </p:cNvPr>
          <p:cNvSpPr txBox="1"/>
          <p:nvPr/>
        </p:nvSpPr>
        <p:spPr>
          <a:xfrm>
            <a:off x="9345567" y="3130841"/>
            <a:ext cx="4988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Fold</a:t>
            </a:r>
          </a:p>
          <a:p>
            <a:pPr algn="ctr"/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Change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783C18-915B-B659-B006-C7B485503742}"/>
              </a:ext>
            </a:extLst>
          </p:cNvPr>
          <p:cNvSpPr txBox="1"/>
          <p:nvPr/>
        </p:nvSpPr>
        <p:spPr>
          <a:xfrm>
            <a:off x="7974640" y="319380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1.0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5BD234A-7967-CCC0-69AF-772D2BF9FD17}"/>
              </a:ext>
            </a:extLst>
          </p:cNvPr>
          <p:cNvSpPr txBox="1"/>
          <p:nvPr/>
        </p:nvSpPr>
        <p:spPr>
          <a:xfrm>
            <a:off x="8347861" y="3190752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0.6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4C8804-B0BE-BE0E-5838-F3FF2A774990}"/>
              </a:ext>
            </a:extLst>
          </p:cNvPr>
          <p:cNvSpPr txBox="1"/>
          <p:nvPr/>
        </p:nvSpPr>
        <p:spPr>
          <a:xfrm>
            <a:off x="8681564" y="3190752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1.1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2797191-9882-22AC-7C4E-53D2C8718F7D}"/>
              </a:ext>
            </a:extLst>
          </p:cNvPr>
          <p:cNvSpPr txBox="1"/>
          <p:nvPr/>
        </p:nvSpPr>
        <p:spPr>
          <a:xfrm>
            <a:off x="8981620" y="3184491"/>
            <a:ext cx="314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Calibri" panose="020F0502020204030204" pitchFamily="34" charset="0"/>
                <a:cs typeface="Calibri" panose="020F0502020204030204" pitchFamily="34" charset="0"/>
              </a:rPr>
              <a:t>0.7</a:t>
            </a:r>
            <a:endParaRPr lang="ko-KR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2304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9</TotalTime>
  <Words>122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Palatino Linotype</vt:lpstr>
      <vt:lpstr>Office 테마</vt:lpstr>
      <vt:lpstr>Imag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hee Kim</dc:creator>
  <cp:lastModifiedBy>MDPI</cp:lastModifiedBy>
  <cp:revision>39</cp:revision>
  <dcterms:created xsi:type="dcterms:W3CDTF">2022-12-06T06:53:04Z</dcterms:created>
  <dcterms:modified xsi:type="dcterms:W3CDTF">2023-01-16T08:31:25Z</dcterms:modified>
</cp:coreProperties>
</file>